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1" r:id="rId3"/>
  </p:sldIdLst>
  <p:sldSz cx="12192000" cy="6858000"/>
  <p:notesSz cx="6858000" cy="9144000"/>
  <p:defaultTextStyle>
    <a:defPPr>
      <a:defRPr lang="LID4096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0738E9B-D014-4925-A202-D6E3EE593380}" v="3" dt="2023-08-09T09:19:01.91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7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hmed Sallam" userId="c0f5480f-e077-4e49-9753-0058681f53f0" providerId="ADAL" clId="{70738E9B-D014-4925-A202-D6E3EE593380}"/>
    <pc:docChg chg="undo custSel addSld modSld sldOrd">
      <pc:chgData name="Ahmed Sallam" userId="c0f5480f-e077-4e49-9753-0058681f53f0" providerId="ADAL" clId="{70738E9B-D014-4925-A202-D6E3EE593380}" dt="2023-08-09T09:22:32.332" v="28" actId="14100"/>
      <pc:docMkLst>
        <pc:docMk/>
      </pc:docMkLst>
      <pc:sldChg chg="modSp mod ord">
        <pc:chgData name="Ahmed Sallam" userId="c0f5480f-e077-4e49-9753-0058681f53f0" providerId="ADAL" clId="{70738E9B-D014-4925-A202-D6E3EE593380}" dt="2023-08-09T09:21:05.458" v="27" actId="20577"/>
        <pc:sldMkLst>
          <pc:docMk/>
          <pc:sldMk cId="2106917052" sldId="261"/>
        </pc:sldMkLst>
        <pc:spChg chg="mod">
          <ac:chgData name="Ahmed Sallam" userId="c0f5480f-e077-4e49-9753-0058681f53f0" providerId="ADAL" clId="{70738E9B-D014-4925-A202-D6E3EE593380}" dt="2023-08-09T09:21:05.458" v="27" actId="20577"/>
          <ac:spMkLst>
            <pc:docMk/>
            <pc:sldMk cId="2106917052" sldId="261"/>
            <ac:spMk id="3" creationId="{00000000-0000-0000-0000-000000000000}"/>
          </ac:spMkLst>
        </pc:spChg>
      </pc:sldChg>
      <pc:sldChg chg="addSp delSp modSp new mod setBg">
        <pc:chgData name="Ahmed Sallam" userId="c0f5480f-e077-4e49-9753-0058681f53f0" providerId="ADAL" clId="{70738E9B-D014-4925-A202-D6E3EE593380}" dt="2023-08-09T09:22:32.332" v="28" actId="14100"/>
        <pc:sldMkLst>
          <pc:docMk/>
          <pc:sldMk cId="2313672289" sldId="262"/>
        </pc:sldMkLst>
        <pc:spChg chg="add mod">
          <ac:chgData name="Ahmed Sallam" userId="c0f5480f-e077-4e49-9753-0058681f53f0" providerId="ADAL" clId="{70738E9B-D014-4925-A202-D6E3EE593380}" dt="2023-08-09T09:20:57.338" v="24" actId="1076"/>
          <ac:spMkLst>
            <pc:docMk/>
            <pc:sldMk cId="2313672289" sldId="262"/>
            <ac:spMk id="5" creationId="{C734E98C-24ED-8059-6F0B-5E95DA60F9B5}"/>
          </ac:spMkLst>
        </pc:spChg>
        <pc:spChg chg="add del">
          <ac:chgData name="Ahmed Sallam" userId="c0f5480f-e077-4e49-9753-0058681f53f0" providerId="ADAL" clId="{70738E9B-D014-4925-A202-D6E3EE593380}" dt="2023-08-09T09:18:41.359" v="6" actId="26606"/>
          <ac:spMkLst>
            <pc:docMk/>
            <pc:sldMk cId="2313672289" sldId="262"/>
            <ac:spMk id="9" creationId="{42A4FC2C-047E-45A5-965D-8E1E3BF09BC6}"/>
          </ac:spMkLst>
        </pc:spChg>
        <pc:graphicFrameChg chg="add del mod">
          <ac:chgData name="Ahmed Sallam" userId="c0f5480f-e077-4e49-9753-0058681f53f0" providerId="ADAL" clId="{70738E9B-D014-4925-A202-D6E3EE593380}" dt="2023-08-09T09:17:33.270" v="2"/>
          <ac:graphicFrameMkLst>
            <pc:docMk/>
            <pc:sldMk cId="2313672289" sldId="262"/>
            <ac:graphicFrameMk id="2" creationId="{CF4F4964-61E0-D46E-9318-365E81CFE58E}"/>
          </ac:graphicFrameMkLst>
        </pc:graphicFrameChg>
        <pc:picChg chg="add mod modCrop">
          <ac:chgData name="Ahmed Sallam" userId="c0f5480f-e077-4e49-9753-0058681f53f0" providerId="ADAL" clId="{70738E9B-D014-4925-A202-D6E3EE593380}" dt="2023-08-09T09:22:32.332" v="28" actId="14100"/>
          <ac:picMkLst>
            <pc:docMk/>
            <pc:sldMk cId="2313672289" sldId="262"/>
            <ac:picMk id="4" creationId="{432C6557-FD87-12D3-548C-BD85A78AD35E}"/>
          </ac:picMkLst>
        </pc:picChg>
        <pc:picChg chg="add del mod">
          <ac:chgData name="Ahmed Sallam" userId="c0f5480f-e077-4e49-9753-0058681f53f0" providerId="ADAL" clId="{70738E9B-D014-4925-A202-D6E3EE593380}" dt="2023-08-09T09:17:33.270" v="2"/>
          <ac:picMkLst>
            <pc:docMk/>
            <pc:sldMk cId="2313672289" sldId="262"/>
            <ac:picMk id="1025" creationId="{B7A5B521-7983-AD64-B755-AB5385CFA417}"/>
          </ac:picMkLst>
        </pc:picChg>
        <pc:picChg chg="add del mod">
          <ac:chgData name="Ahmed Sallam" userId="c0f5480f-e077-4e49-9753-0058681f53f0" providerId="ADAL" clId="{70738E9B-D014-4925-A202-D6E3EE593380}" dt="2023-08-09T09:17:33.270" v="2"/>
          <ac:picMkLst>
            <pc:docMk/>
            <pc:sldMk cId="2313672289" sldId="262"/>
            <ac:picMk id="1026" creationId="{B8590346-8B9C-B7CD-9C33-867359EE1B52}"/>
          </ac:picMkLst>
        </pc:picChg>
        <pc:picChg chg="add del mod">
          <ac:chgData name="Ahmed Sallam" userId="c0f5480f-e077-4e49-9753-0058681f53f0" providerId="ADAL" clId="{70738E9B-D014-4925-A202-D6E3EE593380}" dt="2023-08-09T09:17:33.270" v="2"/>
          <ac:picMkLst>
            <pc:docMk/>
            <pc:sldMk cId="2313672289" sldId="262"/>
            <ac:picMk id="1027" creationId="{B667B58E-24AB-4204-656C-5E5D9EF6D7EC}"/>
          </ac:picMkLst>
        </pc:picChg>
        <pc:picChg chg="add del mod">
          <ac:chgData name="Ahmed Sallam" userId="c0f5480f-e077-4e49-9753-0058681f53f0" providerId="ADAL" clId="{70738E9B-D014-4925-A202-D6E3EE593380}" dt="2023-08-09T09:17:33.270" v="2"/>
          <ac:picMkLst>
            <pc:docMk/>
            <pc:sldMk cId="2313672289" sldId="262"/>
            <ac:picMk id="1028" creationId="{6DAB765A-7AEA-B77A-499B-08CD2900F719}"/>
          </ac:picMkLst>
        </pc:picChg>
        <pc:picChg chg="add del mod">
          <ac:chgData name="Ahmed Sallam" userId="c0f5480f-e077-4e49-9753-0058681f53f0" providerId="ADAL" clId="{70738E9B-D014-4925-A202-D6E3EE593380}" dt="2023-08-09T09:17:33.270" v="2"/>
          <ac:picMkLst>
            <pc:docMk/>
            <pc:sldMk cId="2313672289" sldId="262"/>
            <ac:picMk id="1029" creationId="{841A90E8-CEE6-F3F1-9826-7E4E2973F250}"/>
          </ac:picMkLst>
        </pc:picChg>
        <pc:picChg chg="add del mod">
          <ac:chgData name="Ahmed Sallam" userId="c0f5480f-e077-4e49-9753-0058681f53f0" providerId="ADAL" clId="{70738E9B-D014-4925-A202-D6E3EE593380}" dt="2023-08-09T09:17:33.270" v="2"/>
          <ac:picMkLst>
            <pc:docMk/>
            <pc:sldMk cId="2313672289" sldId="262"/>
            <ac:picMk id="1030" creationId="{8BAF870E-D189-EFCA-1A74-F58AA68BECE6}"/>
          </ac:picMkLst>
        </pc:picChg>
        <pc:picChg chg="add del mod">
          <ac:chgData name="Ahmed Sallam" userId="c0f5480f-e077-4e49-9753-0058681f53f0" providerId="ADAL" clId="{70738E9B-D014-4925-A202-D6E3EE593380}" dt="2023-08-09T09:17:33.270" v="2"/>
          <ac:picMkLst>
            <pc:docMk/>
            <pc:sldMk cId="2313672289" sldId="262"/>
            <ac:picMk id="1031" creationId="{E12AA38A-4F56-6861-0748-6D783C55833E}"/>
          </ac:picMkLst>
        </pc:picChg>
        <pc:picChg chg="add del mod">
          <ac:chgData name="Ahmed Sallam" userId="c0f5480f-e077-4e49-9753-0058681f53f0" providerId="ADAL" clId="{70738E9B-D014-4925-A202-D6E3EE593380}" dt="2023-08-09T09:17:33.270" v="2"/>
          <ac:picMkLst>
            <pc:docMk/>
            <pc:sldMk cId="2313672289" sldId="262"/>
            <ac:picMk id="1032" creationId="{7D7A1998-286A-1120-3FBA-F99F4B7ED08E}"/>
          </ac:picMkLst>
        </pc:picChg>
        <pc:picChg chg="add del mod">
          <ac:chgData name="Ahmed Sallam" userId="c0f5480f-e077-4e49-9753-0058681f53f0" providerId="ADAL" clId="{70738E9B-D014-4925-A202-D6E3EE593380}" dt="2023-08-09T09:17:33.270" v="2"/>
          <ac:picMkLst>
            <pc:docMk/>
            <pc:sldMk cId="2313672289" sldId="262"/>
            <ac:picMk id="1033" creationId="{FDEFCFA9-B905-C52B-B038-E286AF957CBB}"/>
          </ac:picMkLst>
        </pc:picChg>
        <pc:picChg chg="add del mod">
          <ac:chgData name="Ahmed Sallam" userId="c0f5480f-e077-4e49-9753-0058681f53f0" providerId="ADAL" clId="{70738E9B-D014-4925-A202-D6E3EE593380}" dt="2023-08-09T09:17:33.270" v="2"/>
          <ac:picMkLst>
            <pc:docMk/>
            <pc:sldMk cId="2313672289" sldId="262"/>
            <ac:picMk id="1034" creationId="{73CC6288-22F6-169A-1AAD-B31E69C1A6F0}"/>
          </ac:picMkLst>
        </pc:picChg>
        <pc:picChg chg="add del mod">
          <ac:chgData name="Ahmed Sallam" userId="c0f5480f-e077-4e49-9753-0058681f53f0" providerId="ADAL" clId="{70738E9B-D014-4925-A202-D6E3EE593380}" dt="2023-08-09T09:17:33.270" v="2"/>
          <ac:picMkLst>
            <pc:docMk/>
            <pc:sldMk cId="2313672289" sldId="262"/>
            <ac:picMk id="1035" creationId="{D001FABE-301F-0DDB-B8F0-2574FE5F25B7}"/>
          </ac:picMkLst>
        </pc:picChg>
        <pc:picChg chg="add del mod">
          <ac:chgData name="Ahmed Sallam" userId="c0f5480f-e077-4e49-9753-0058681f53f0" providerId="ADAL" clId="{70738E9B-D014-4925-A202-D6E3EE593380}" dt="2023-08-09T09:17:33.270" v="2"/>
          <ac:picMkLst>
            <pc:docMk/>
            <pc:sldMk cId="2313672289" sldId="262"/>
            <ac:picMk id="1036" creationId="{6824AF0F-032B-59D0-0C5C-F4371887842B}"/>
          </ac:picMkLst>
        </pc:pic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C:\Users\Administrator\Downloads\heba%20data%201%20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Control disease</c:v>
          </c:tx>
          <c:spPr>
            <a:solidFill>
              <a:schemeClr val="accent1">
                <a:alpha val="70000"/>
              </a:schemeClr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3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B52D-4DE4-91DF-CD38B6BE447C}"/>
              </c:ext>
            </c:extLst>
          </c:dPt>
          <c:cat>
            <c:strRef>
              <c:f>('final GE analysis'!$Q$22,'final GE analysis'!$Q$23,'final GE analysis'!$Q$24,'final GE analysis'!$Q$25)</c:f>
              <c:strCache>
                <c:ptCount val="4"/>
                <c:pt idx="0">
                  <c:v>Control healthy</c:v>
                </c:pt>
                <c:pt idx="1">
                  <c:v>A. Solani</c:v>
                </c:pt>
                <c:pt idx="2">
                  <c:v>C. Lunata</c:v>
                </c:pt>
                <c:pt idx="3">
                  <c:v>A. Alternata</c:v>
                </c:pt>
              </c:strCache>
            </c:strRef>
          </c:cat>
          <c:val>
            <c:numRef>
              <c:f>('final GE analysis'!$R$22,'final GE analysis'!$R$23,'final GE analysis'!$R$24,'final GE analysis'!$R$25)</c:f>
              <c:numCache>
                <c:formatCode>General</c:formatCode>
                <c:ptCount val="4"/>
                <c:pt idx="0">
                  <c:v>0.72852580260139599</c:v>
                </c:pt>
                <c:pt idx="1">
                  <c:v>0.47798421273660047</c:v>
                </c:pt>
                <c:pt idx="2">
                  <c:v>0.99654026282787156</c:v>
                </c:pt>
                <c:pt idx="3">
                  <c:v>0.996540262827868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52D-4DE4-91DF-CD38B6BE447C}"/>
            </c:ext>
          </c:extLst>
        </c:ser>
        <c:ser>
          <c:idx val="1"/>
          <c:order val="1"/>
          <c:tx>
            <c:v> (EC)</c:v>
          </c:tx>
          <c:spPr>
            <a:solidFill>
              <a:schemeClr val="accent2">
                <a:alpha val="70000"/>
              </a:schemeClr>
            </a:solidFill>
            <a:ln>
              <a:noFill/>
            </a:ln>
            <a:effectLst/>
          </c:spPr>
          <c:invertIfNegative val="0"/>
          <c:cat>
            <c:strRef>
              <c:f>('final GE analysis'!$Q$22,'final GE analysis'!$Q$23,'final GE analysis'!$Q$24,'final GE analysis'!$Q$25)</c:f>
              <c:strCache>
                <c:ptCount val="4"/>
                <c:pt idx="0">
                  <c:v>Control healthy</c:v>
                </c:pt>
                <c:pt idx="1">
                  <c:v>A. Solani</c:v>
                </c:pt>
                <c:pt idx="2">
                  <c:v>C. Lunata</c:v>
                </c:pt>
                <c:pt idx="3">
                  <c:v>A. Alternata</c:v>
                </c:pt>
              </c:strCache>
            </c:strRef>
          </c:cat>
          <c:val>
            <c:numRef>
              <c:f>('final GE analysis'!$S$22,'final GE analysis'!$S$23,'final GE analysis'!$S$24,'final GE analysis'!$S$25)</c:f>
              <c:numCache>
                <c:formatCode>General</c:formatCode>
                <c:ptCount val="4"/>
                <c:pt idx="1">
                  <c:v>1.9950030762855933</c:v>
                </c:pt>
                <c:pt idx="2">
                  <c:v>9.1386379008227134</c:v>
                </c:pt>
                <c:pt idx="3">
                  <c:v>6.56626553543603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B52D-4DE4-91DF-CD38B6BE447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1609962032"/>
        <c:axId val="1609952880"/>
      </c:barChart>
      <c:catAx>
        <c:axId val="16099620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>
              <a:defRPr lang="en-US" sz="1400" b="1" i="0" u="none" strike="noStrike" kern="1200" cap="none" spc="20" normalizeH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609952880"/>
        <c:crosses val="autoZero"/>
        <c:auto val="1"/>
        <c:lblAlgn val="ctr"/>
        <c:lblOffset val="100"/>
        <c:noMultiLvlLbl val="0"/>
      </c:catAx>
      <c:valAx>
        <c:axId val="160995288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en-US" sz="1400" b="1" i="0" u="none" strike="noStrike" kern="1200" cap="all" spc="2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dd ct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en-US" sz="1400" b="1" i="0" u="none" strike="noStrike" kern="1200" cap="all" spc="2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>
              <a:defRPr lang="en-US" sz="1400" b="1" i="0" u="none" strike="noStrike" kern="1200" spc="2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60996203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en-US" sz="1400" b="1" i="0" u="none" strike="noStrike" kern="1200" spc="2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 algn="ctr">
        <a:defRPr lang="en-US" sz="1400" b="1" i="0" u="none" strike="noStrike" kern="1200" spc="20" baseline="0">
          <a:solidFill>
            <a:sysClr val="windowText" lastClr="000000"/>
          </a:solidFill>
          <a:latin typeface="Times New Roman" panose="02020603050405020304" pitchFamily="18" charset="0"/>
          <a:ea typeface="+mn-ea"/>
          <a:cs typeface="Times New Roman" panose="02020603050405020304" pitchFamily="18" charset="0"/>
        </a:defRPr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5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587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 cap="none" spc="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bg1"/>
    </cs:fontRef>
    <cs:spPr>
      <a:solidFill>
        <a:schemeClr val="tx1">
          <a:lumMod val="50000"/>
          <a:lumOff val="50000"/>
        </a:schemeClr>
      </a:solidFill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70000"/>
        </a:schemeClr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70000"/>
        </a:schemeClr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>
            <a:alpha val="70000"/>
          </a:schemeClr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70000"/>
        </a:schemeClr>
      </a:solidFill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 baseline="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ajor">
      <a:schemeClr val="tx1">
        <a:lumMod val="65000"/>
        <a:lumOff val="35000"/>
      </a:schemeClr>
    </cs:fontRef>
    <cs:defRPr sz="1600" b="0" i="0" kern="1200" cap="none" spc="5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587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 spc="20" baseline="0"/>
  </cs:valueAxis>
  <cs:wall>
    <cs:lnRef idx="0"/>
    <cs:fillRef idx="0"/>
    <cs:effectRef idx="0"/>
    <cs:fontRef idx="minor">
      <a:schemeClr val="dk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D08EA2-F536-C7C4-2253-F753A3575FC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LID4096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1AB0004-372B-F58D-8A59-DFA0CDF6280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LID4096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6E94C2-1F80-8462-24D0-0D1F4F6457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369EE-B902-42C5-AF51-76970E7F9699}" type="datetimeFigureOut">
              <a:rPr lang="LID4096" smtClean="0"/>
              <a:t>08/09/2023</a:t>
            </a:fld>
            <a:endParaRPr lang="LID4096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A70EAB-DF4E-DCAB-3147-C0E4149FFE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ECE0CE-5D75-6A5C-0240-FDA4FB68AA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B7E48-A31F-4A1A-82E3-F461B97079B7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34891856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099248-CCDF-E145-05B5-784B458E80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LID4096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21EC2C5-CAB6-FD53-66C6-9BEBB8C1618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ID4096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AF2DB2-69C6-86E3-0263-3F6B30D2C5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369EE-B902-42C5-AF51-76970E7F9699}" type="datetimeFigureOut">
              <a:rPr lang="LID4096" smtClean="0"/>
              <a:t>08/09/2023</a:t>
            </a:fld>
            <a:endParaRPr lang="LID4096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865E8B-D3A2-EEBA-BA4F-DB31B0613E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A50D60-924E-B211-13FE-8C99FAD752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B7E48-A31F-4A1A-82E3-F461B97079B7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15425767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DEFA829-94B1-3EB9-7C58-8BB661643E6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LID4096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396090C-FEEB-C158-515A-96D652C0E9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ID4096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C0AECA-DEF7-B843-88BF-739CC84D65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369EE-B902-42C5-AF51-76970E7F9699}" type="datetimeFigureOut">
              <a:rPr lang="LID4096" smtClean="0"/>
              <a:t>08/09/2023</a:t>
            </a:fld>
            <a:endParaRPr lang="LID4096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3E0A14-C89C-565F-34D7-8E50AC4E75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5C7BE8-1F2F-9229-883E-DB0765874F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B7E48-A31F-4A1A-82E3-F461B97079B7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9368975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A7E158-6E09-30EB-3751-494109C8D8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LID4096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45F0548-7C7B-A3A4-1399-6765A1BEE49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ID4096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986EB8-0151-3BEA-9E4A-6368CC28DB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369EE-B902-42C5-AF51-76970E7F9699}" type="datetimeFigureOut">
              <a:rPr lang="LID4096" smtClean="0"/>
              <a:t>08/09/2023</a:t>
            </a:fld>
            <a:endParaRPr lang="LID4096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65B23B-0333-E497-1B63-ED0D584F2E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A2D616-6759-21E4-87FE-B3ABE7CD62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B7E48-A31F-4A1A-82E3-F461B97079B7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5733967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3EA111-E1E7-E515-40AC-AF8BD60A6B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LID4096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AF8657C-AD07-CC9D-3BA4-F8967B556E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1652EF-47EE-3C22-C674-8A5BC6A205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369EE-B902-42C5-AF51-76970E7F9699}" type="datetimeFigureOut">
              <a:rPr lang="LID4096" smtClean="0"/>
              <a:t>08/09/2023</a:t>
            </a:fld>
            <a:endParaRPr lang="LID4096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5B68C3-DDFB-50B4-A09C-E0D90CAA00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867139-E21E-26CE-C186-8FBF728B99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B7E48-A31F-4A1A-82E3-F461B97079B7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12244439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51833A-B323-6910-3585-CFC51A1323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LID4096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2A6D775-725A-3945-26EF-F8E3F1EDB8D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ID4096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AC626D2-7FED-CE44-AF99-E06A832D0A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ID4096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26EDB49-5FF7-985E-41DD-9EFE0E219E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369EE-B902-42C5-AF51-76970E7F9699}" type="datetimeFigureOut">
              <a:rPr lang="LID4096" smtClean="0"/>
              <a:t>08/09/2023</a:t>
            </a:fld>
            <a:endParaRPr lang="LID4096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87E506-7E47-D127-0107-270DD3EBD7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7CBD96F-16DC-0A44-43C3-5C5AA73146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B7E48-A31F-4A1A-82E3-F461B97079B7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9571243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9410B4-4316-8194-E524-3079E79639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LID4096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42B66A7-C9A7-6724-141E-DCEDB99AF1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ADC6744-72A0-D526-9C25-CDEA27EC9C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ID4096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A44ED9C-5B00-1E29-80EA-7A071880486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AAC4B2B-6747-1645-5FB0-07B15F1DF20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ID4096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E54B6EC-CDE4-AD99-E5FE-D13DBC5684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369EE-B902-42C5-AF51-76970E7F9699}" type="datetimeFigureOut">
              <a:rPr lang="LID4096" smtClean="0"/>
              <a:t>08/09/2023</a:t>
            </a:fld>
            <a:endParaRPr lang="LID4096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8051DB1-37AB-CC3D-84D8-3E27F93FC7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DFBFB5C-48B5-3054-D3D5-6D98260D55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B7E48-A31F-4A1A-82E3-F461B97079B7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8357132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B5B3B6-C9C5-BDEA-C71D-EED1AC8F20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LID4096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1E2A246-4FB2-1F75-E5E9-70E6244E68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369EE-B902-42C5-AF51-76970E7F9699}" type="datetimeFigureOut">
              <a:rPr lang="LID4096" smtClean="0"/>
              <a:t>08/09/2023</a:t>
            </a:fld>
            <a:endParaRPr lang="LID4096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C937DD6-90A3-B27B-6AA2-92B46FF498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87F6FEE-9ED5-3297-74DD-54E78E519A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B7E48-A31F-4A1A-82E3-F461B97079B7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41100206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E62F034-A723-582E-2898-95091FA298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369EE-B902-42C5-AF51-76970E7F9699}" type="datetimeFigureOut">
              <a:rPr lang="LID4096" smtClean="0"/>
              <a:t>08/09/2023</a:t>
            </a:fld>
            <a:endParaRPr lang="LID4096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3452D64-4641-A797-D8EA-E554A1C3F8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C751323-8931-5564-F15F-31C50C9AE8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B7E48-A31F-4A1A-82E3-F461B97079B7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22335682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975D24-8155-C510-114F-5F7EA9620B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LID4096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D8C040C-5038-C865-1E8F-7FCB5F9BE2E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ID4096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754DBD7-EB52-3511-CB9F-6B93F877DCA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1BC30E-E056-565A-3D08-739CD12050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369EE-B902-42C5-AF51-76970E7F9699}" type="datetimeFigureOut">
              <a:rPr lang="LID4096" smtClean="0"/>
              <a:t>08/09/2023</a:t>
            </a:fld>
            <a:endParaRPr lang="LID4096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E2829FC-3918-E8C6-4FD8-4B144CD7A7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B4ED02-8FE4-B0FC-A14C-AEC69E8883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B7E48-A31F-4A1A-82E3-F461B97079B7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12062876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31C026-D9AB-1AAC-4F27-42601F570D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LID4096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BD73DEB-B15D-50D0-36F2-ADD9E14C3D2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LID4096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1700545-AD75-9B46-A570-352FC84783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BDEED76-9B9E-7E89-5537-86FDDF4C58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369EE-B902-42C5-AF51-76970E7F9699}" type="datetimeFigureOut">
              <a:rPr lang="LID4096" smtClean="0"/>
              <a:t>08/09/2023</a:t>
            </a:fld>
            <a:endParaRPr lang="LID4096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858430A-3432-FCFE-BB6E-9ED7838D6E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ID4096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4FD6C21-541B-68D7-B1FE-3D6434FF67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B7E48-A31F-4A1A-82E3-F461B97079B7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16881483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D3ADCCA-A161-0689-37A5-6A2B6F2AA0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LID4096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53B834C-96A5-0E0F-AB5B-29B9A28209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LID4096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B31F79-B7F2-2A13-95E0-BBA4E284BBC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5369EE-B902-42C5-AF51-76970E7F9699}" type="datetimeFigureOut">
              <a:rPr lang="LID4096" smtClean="0"/>
              <a:t>08/09/2023</a:t>
            </a:fld>
            <a:endParaRPr lang="LID4096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F33775-ACBD-4FC4-E1D9-3AA6C2846AF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LID4096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42F23E-EDC7-6301-AB18-1C778E7DD98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4B7E48-A31F-4A1A-82E3-F461B97079B7}" type="slidenum">
              <a:rPr lang="LID4096" smtClean="0"/>
              <a:t>‹#›</a:t>
            </a:fld>
            <a:endParaRPr lang="LID4096"/>
          </a:p>
        </p:txBody>
      </p:sp>
    </p:spTree>
    <p:extLst>
      <p:ext uri="{BB962C8B-B14F-4D97-AF65-F5344CB8AC3E}">
        <p14:creationId xmlns:p14="http://schemas.microsoft.com/office/powerpoint/2010/main" val="27120914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LID4096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432C6557-FD87-12D3-548C-BD85A78AD35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535"/>
          <a:stretch/>
        </p:blipFill>
        <p:spPr>
          <a:xfrm>
            <a:off x="0" y="0"/>
            <a:ext cx="6890158" cy="663569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734E98C-24ED-8059-6F0B-5E95DA60F9B5}"/>
              </a:ext>
            </a:extLst>
          </p:cNvPr>
          <p:cNvSpPr txBox="1"/>
          <p:nvPr/>
        </p:nvSpPr>
        <p:spPr>
          <a:xfrm>
            <a:off x="6890158" y="4979301"/>
            <a:ext cx="5301842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538163" indent="-538163" algn="just"/>
            <a:r>
              <a:rPr lang="en-US" b="1" dirty="0"/>
              <a:t>Supplementary Figure 1: The average PR gene expression during the 10 days in inoculated tomato leave with pathogenic fungi (</a:t>
            </a:r>
            <a:r>
              <a:rPr lang="en-US" b="1" i="1" dirty="0"/>
              <a:t>A. </a:t>
            </a:r>
            <a:r>
              <a:rPr lang="en-US" b="1" i="1" dirty="0" err="1"/>
              <a:t>solai</a:t>
            </a:r>
            <a:r>
              <a:rPr lang="en-US" b="1" dirty="0"/>
              <a:t> , </a:t>
            </a:r>
            <a:r>
              <a:rPr lang="en-US" b="1" i="1" dirty="0"/>
              <a:t>C. </a:t>
            </a:r>
            <a:r>
              <a:rPr lang="en-US" b="1" i="1" dirty="0" err="1"/>
              <a:t>lunata</a:t>
            </a:r>
            <a:r>
              <a:rPr lang="en-US" b="1" i="1" dirty="0"/>
              <a:t>, A. </a:t>
            </a:r>
            <a:r>
              <a:rPr lang="en-US" b="1" i="1" dirty="0" err="1"/>
              <a:t>alternata</a:t>
            </a:r>
            <a:r>
              <a:rPr lang="en-US" b="1" dirty="0"/>
              <a:t>)</a:t>
            </a:r>
            <a:r>
              <a:rPr lang="en-US" b="1" i="1" dirty="0"/>
              <a:t>  </a:t>
            </a:r>
            <a:r>
              <a:rPr lang="en-US" b="1" dirty="0"/>
              <a:t>and endophytic bacteria EC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136722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/>
        </p:nvGraphicFramePr>
        <p:xfrm>
          <a:off x="1280161" y="-1"/>
          <a:ext cx="9777046" cy="47830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748145" y="5056909"/>
            <a:ext cx="1062643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538163" indent="-538163"/>
            <a:r>
              <a:rPr lang="en-US" b="1" dirty="0"/>
              <a:t>Supplementary Figure 2: The average PR gene expression during the 10 days in inoculated tomato leave with pathogenic fungi (</a:t>
            </a:r>
            <a:r>
              <a:rPr lang="en-US" b="1" i="1" dirty="0"/>
              <a:t>A. </a:t>
            </a:r>
            <a:r>
              <a:rPr lang="en-US" b="1" i="1" dirty="0" err="1"/>
              <a:t>solai</a:t>
            </a:r>
            <a:r>
              <a:rPr lang="en-US" b="1" dirty="0"/>
              <a:t> , </a:t>
            </a:r>
            <a:r>
              <a:rPr lang="en-US" b="1" i="1" dirty="0"/>
              <a:t>C. </a:t>
            </a:r>
            <a:r>
              <a:rPr lang="en-US" b="1" i="1" dirty="0" err="1"/>
              <a:t>lunata</a:t>
            </a:r>
            <a:r>
              <a:rPr lang="en-US" b="1" i="1" dirty="0"/>
              <a:t>, A. </a:t>
            </a:r>
            <a:r>
              <a:rPr lang="en-US" b="1" i="1" dirty="0" err="1"/>
              <a:t>alternata</a:t>
            </a:r>
            <a:r>
              <a:rPr lang="en-US" b="1" dirty="0"/>
              <a:t>)</a:t>
            </a:r>
            <a:r>
              <a:rPr lang="en-US" b="1" i="1" dirty="0"/>
              <a:t>  </a:t>
            </a:r>
            <a:r>
              <a:rPr lang="en-US" b="1" dirty="0"/>
              <a:t>and endophytic bacteria EC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069170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明朝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78</Words>
  <Application>Microsoft Office PowerPoint</Application>
  <PresentationFormat>Widescreen</PresentationFormat>
  <Paragraphs>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. Ahmed Sallam</dc:creator>
  <cp:lastModifiedBy>Ahmed Sallam</cp:lastModifiedBy>
  <cp:revision>1</cp:revision>
  <dcterms:created xsi:type="dcterms:W3CDTF">2023-05-21T05:45:37Z</dcterms:created>
  <dcterms:modified xsi:type="dcterms:W3CDTF">2023-08-09T09:22:39Z</dcterms:modified>
</cp:coreProperties>
</file>